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1704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08/02/2024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08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65304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1520" y="5633372"/>
            <a:ext cx="799288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Béliard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06100-z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 </a:t>
            </a:r>
            <a:r>
              <a:rPr lang="en-GB" sz="1200" dirty="0"/>
              <a:t>The Author(s), under exclusive licence to Springer-Verlag GmbH Germany, part of Springer Nature 2024</a:t>
            </a:r>
            <a:endParaRPr kumimoji="0" lang="en-GB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b="1" dirty="0"/>
              <a:t>Newly approved and potential future therapies targeting circulating lipoparticle metabolism </a:t>
            </a:r>
            <a:endParaRPr lang="en-GB" sz="1800" b="1" dirty="0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B1F9B0B-E8F6-3962-8C13-2398C700428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08874" y="1043008"/>
            <a:ext cx="6726252" cy="49062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On-screen Show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47</cp:revision>
  <dcterms:created xsi:type="dcterms:W3CDTF">2016-06-15T12:53:43Z</dcterms:created>
  <dcterms:modified xsi:type="dcterms:W3CDTF">2024-02-08T12:01:47Z</dcterms:modified>
</cp:coreProperties>
</file>